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315" r:id="rId5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2194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ro Tunheim" userId="a68614e0-426d-4fcb-ad9c-27f20f40851b" providerId="ADAL" clId="{70FE5D21-1CF4-4BBA-BCA8-17BE2A453FC6}"/>
    <pc:docChg chg="undo custSel modSld">
      <pc:chgData name="Gro Tunheim" userId="a68614e0-426d-4fcb-ad9c-27f20f40851b" providerId="ADAL" clId="{70FE5D21-1CF4-4BBA-BCA8-17BE2A453FC6}" dt="2024-08-08T12:28:24.573" v="108" actId="1076"/>
      <pc:docMkLst>
        <pc:docMk/>
      </pc:docMkLst>
      <pc:sldChg chg="addSp delSp modSp mod">
        <pc:chgData name="Gro Tunheim" userId="a68614e0-426d-4fcb-ad9c-27f20f40851b" providerId="ADAL" clId="{70FE5D21-1CF4-4BBA-BCA8-17BE2A453FC6}" dt="2024-08-08T12:28:24.573" v="108" actId="1076"/>
        <pc:sldMkLst>
          <pc:docMk/>
          <pc:sldMk cId="383319126" sldId="315"/>
        </pc:sldMkLst>
        <pc:spChg chg="mod">
          <ac:chgData name="Gro Tunheim" userId="a68614e0-426d-4fcb-ad9c-27f20f40851b" providerId="ADAL" clId="{70FE5D21-1CF4-4BBA-BCA8-17BE2A453FC6}" dt="2024-08-08T12:28:16.586" v="105" actId="1035"/>
          <ac:spMkLst>
            <pc:docMk/>
            <pc:sldMk cId="383319126" sldId="315"/>
            <ac:spMk id="2" creationId="{23F08AEF-E0A6-E7B8-B540-58799ECD69FB}"/>
          </ac:spMkLst>
        </pc:spChg>
        <pc:spChg chg="add del">
          <ac:chgData name="Gro Tunheim" userId="a68614e0-426d-4fcb-ad9c-27f20f40851b" providerId="ADAL" clId="{70FE5D21-1CF4-4BBA-BCA8-17BE2A453FC6}" dt="2024-08-08T12:27:39.528" v="1" actId="22"/>
          <ac:spMkLst>
            <pc:docMk/>
            <pc:sldMk cId="383319126" sldId="315"/>
            <ac:spMk id="4" creationId="{FB6A1D41-EB4B-F069-9CE4-25C7F9E1A798}"/>
          </ac:spMkLst>
        </pc:spChg>
        <pc:spChg chg="add mod">
          <ac:chgData name="Gro Tunheim" userId="a68614e0-426d-4fcb-ad9c-27f20f40851b" providerId="ADAL" clId="{70FE5D21-1CF4-4BBA-BCA8-17BE2A453FC6}" dt="2024-08-08T12:28:24.573" v="108" actId="1076"/>
          <ac:spMkLst>
            <pc:docMk/>
            <pc:sldMk cId="383319126" sldId="315"/>
            <ac:spMk id="7" creationId="{9919D7C1-8121-FBFF-5B70-EEE9CC626E18}"/>
          </ac:spMkLst>
        </pc:spChg>
        <pc:picChg chg="mod">
          <ac:chgData name="Gro Tunheim" userId="a68614e0-426d-4fcb-ad9c-27f20f40851b" providerId="ADAL" clId="{70FE5D21-1CF4-4BBA-BCA8-17BE2A453FC6}" dt="2024-08-08T12:28:16.586" v="105" actId="1035"/>
          <ac:picMkLst>
            <pc:docMk/>
            <pc:sldMk cId="383319126" sldId="315"/>
            <ac:picMk id="5" creationId="{4BB8C92A-5805-73AD-F66B-FD2B942733BC}"/>
          </ac:picMkLst>
        </pc:picChg>
      </pc:sldChg>
    </pc:docChg>
  </pc:docChgLst>
  <pc:docChgLst>
    <pc:chgData name="Gro Tunheim" userId="a68614e0-426d-4fcb-ad9c-27f20f40851b" providerId="ADAL" clId="{8F7D5CBF-6C89-4435-A436-7DCF71BFD446}"/>
    <pc:docChg chg="custSel modSld">
      <pc:chgData name="Gro Tunheim" userId="a68614e0-426d-4fcb-ad9c-27f20f40851b" providerId="ADAL" clId="{8F7D5CBF-6C89-4435-A436-7DCF71BFD446}" dt="2024-06-05T07:07:21.107" v="0" actId="478"/>
      <pc:docMkLst>
        <pc:docMk/>
      </pc:docMkLst>
      <pc:sldChg chg="delSp mod">
        <pc:chgData name="Gro Tunheim" userId="a68614e0-426d-4fcb-ad9c-27f20f40851b" providerId="ADAL" clId="{8F7D5CBF-6C89-4435-A436-7DCF71BFD446}" dt="2024-06-05T07:07:21.107" v="0" actId="478"/>
        <pc:sldMkLst>
          <pc:docMk/>
          <pc:sldMk cId="383319126" sldId="315"/>
        </pc:sldMkLst>
        <pc:spChg chg="del">
          <ac:chgData name="Gro Tunheim" userId="a68614e0-426d-4fcb-ad9c-27f20f40851b" providerId="ADAL" clId="{8F7D5CBF-6C89-4435-A436-7DCF71BFD446}" dt="2024-06-05T07:07:21.107" v="0" actId="478"/>
          <ac:spMkLst>
            <pc:docMk/>
            <pc:sldMk cId="383319126" sldId="315"/>
            <ac:spMk id="4" creationId="{425BEFDB-784B-6173-CAF8-546759348F6E}"/>
          </ac:spMkLst>
        </pc:spChg>
      </pc:sldChg>
    </pc:docChg>
  </pc:docChgLst>
  <pc:docChgLst>
    <pc:chgData name="Gro Tunheim" userId="a68614e0-426d-4fcb-ad9c-27f20f40851b" providerId="ADAL" clId="{56574537-94E3-4497-A08A-DAFA82A17073}"/>
    <pc:docChg chg="undo custSel modSld">
      <pc:chgData name="Gro Tunheim" userId="a68614e0-426d-4fcb-ad9c-27f20f40851b" providerId="ADAL" clId="{56574537-94E3-4497-A08A-DAFA82A17073}" dt="2024-05-15T07:21:02.885" v="14" actId="1076"/>
      <pc:docMkLst>
        <pc:docMk/>
      </pc:docMkLst>
      <pc:sldChg chg="addSp modSp mod">
        <pc:chgData name="Gro Tunheim" userId="a68614e0-426d-4fcb-ad9c-27f20f40851b" providerId="ADAL" clId="{56574537-94E3-4497-A08A-DAFA82A17073}" dt="2024-05-15T07:21:02.885" v="14" actId="1076"/>
        <pc:sldMkLst>
          <pc:docMk/>
          <pc:sldMk cId="383319126" sldId="315"/>
        </pc:sldMkLst>
        <pc:spChg chg="add mod">
          <ac:chgData name="Gro Tunheim" userId="a68614e0-426d-4fcb-ad9c-27f20f40851b" providerId="ADAL" clId="{56574537-94E3-4497-A08A-DAFA82A17073}" dt="2024-05-15T07:21:02.885" v="14" actId="1076"/>
          <ac:spMkLst>
            <pc:docMk/>
            <pc:sldMk cId="383319126" sldId="315"/>
            <ac:spMk id="2" creationId="{23F08AEF-E0A6-E7B8-B540-58799ECD69FB}"/>
          </ac:spMkLst>
        </pc:spChg>
        <pc:picChg chg="mod">
          <ac:chgData name="Gro Tunheim" userId="a68614e0-426d-4fcb-ad9c-27f20f40851b" providerId="ADAL" clId="{56574537-94E3-4497-A08A-DAFA82A17073}" dt="2024-05-15T07:20:59.334" v="13" actId="1076"/>
          <ac:picMkLst>
            <pc:docMk/>
            <pc:sldMk cId="383319126" sldId="315"/>
            <ac:picMk id="5" creationId="{4BB8C92A-5805-73AD-F66B-FD2B942733BC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op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3" name="Plassholder for dato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BD634A-58CB-4494-B323-E002B4508B0E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4" name="Plassholder for lysbild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b-NO"/>
          </a:p>
        </p:txBody>
      </p:sp>
      <p:sp>
        <p:nvSpPr>
          <p:cNvPr id="5" name="Plassholder for nota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8BBC86-8CAC-4B09-B4CB-CB621919A94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424074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96CD0D-2612-4583-9810-904A63DBBDEF}" type="slidenum">
              <a:rPr lang="nb-NO" smtClean="0"/>
              <a:t>1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886771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ECF17563-B7F1-84BA-85BC-317564149B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Undertittel 2">
            <a:extLst>
              <a:ext uri="{FF2B5EF4-FFF2-40B4-BE49-F238E27FC236}">
                <a16:creationId xmlns:a16="http://schemas.microsoft.com/office/drawing/2014/main" id="{2FB6C665-7173-20D0-163E-058A7BF777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3E168D6A-D427-AC74-43C4-DF8FBAB982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264EC-ED58-4D1F-B582-7040A53B7E4B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F72A30C7-B327-1E7E-250F-1535A84F4C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62456D42-275A-5C83-F05F-B58566E9D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5BD21-EA6F-4C63-82E2-EC81C088635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502965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C6F25D59-C376-44A9-643F-FCFD1656B9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5F1E6F6E-7D4F-C370-459C-F8E4F38428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1A5BC3C6-5BCE-3FE6-C4D8-468371609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264EC-ED58-4D1F-B582-7040A53B7E4B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93CFDD89-1B42-A4CD-FA1E-54E71E5F4A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4BC19964-FE65-C4B2-8A32-4A932F3022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5BD21-EA6F-4C63-82E2-EC81C088635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344675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>
            <a:extLst>
              <a:ext uri="{FF2B5EF4-FFF2-40B4-BE49-F238E27FC236}">
                <a16:creationId xmlns:a16="http://schemas.microsoft.com/office/drawing/2014/main" id="{0E1ED0A6-1D40-DAD6-60A5-215995CF6C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1AE1E154-365B-7CD8-00C2-D00493BD92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7E830A40-53DC-A3CA-E553-D628E1055C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264EC-ED58-4D1F-B582-7040A53B7E4B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FEBE9763-5A48-6935-1FA9-EA68536682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2570C567-E5F1-1FE8-64D5-4D513AEAC1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5BD21-EA6F-4C63-82E2-EC81C088635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530553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4E2FE330-EFA1-2B90-5E56-F178FCDF2E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359D4E4F-AF30-C100-D603-4567B8A656E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44293090-79EF-2FC6-4ED3-C8F7891F38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264EC-ED58-4D1F-B582-7040A53B7E4B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625C896A-2384-8CCE-3BEE-4F0498B318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2528B119-547E-6C24-E64D-2862CD4E56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5BD21-EA6F-4C63-82E2-EC81C088635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462617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B67A50D2-723D-C676-DE3F-BAC9C363FF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9EC62F74-B15C-AE7B-6416-1EC23F21A2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F709DF83-65B4-0FBA-7500-4BF0A53DD8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264EC-ED58-4D1F-B582-7040A53B7E4B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8114E09A-D600-9C92-A82D-FEA50A7020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E81F958C-045D-66C9-66D5-A47228C67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5BD21-EA6F-4C63-82E2-EC81C088635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749209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51687916-71F4-C922-8112-64B58B9A45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879BBECB-217F-C5DE-24B5-F72D117D6A1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E7586AAF-879E-7486-19D1-E16299139F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10FF9486-F550-0638-0FDF-FD545A6AAD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264EC-ED58-4D1F-B582-7040A53B7E4B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07A4E0FD-B928-624D-B023-A0682048F8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8F8BD149-A2A5-09C7-A6F3-E07078A79F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5BD21-EA6F-4C63-82E2-EC81C088635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649500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597FB1BF-3ECB-9621-7C42-85A22C272F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E5624A6B-E766-ED34-5417-192366EA91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C1306F97-BB4F-ED09-837C-22ABDAFCC0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tekst 4">
            <a:extLst>
              <a:ext uri="{FF2B5EF4-FFF2-40B4-BE49-F238E27FC236}">
                <a16:creationId xmlns:a16="http://schemas.microsoft.com/office/drawing/2014/main" id="{D054955B-1AF2-6F5B-CE92-CCB2688F21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6" name="Plassholder for innhold 5">
            <a:extLst>
              <a:ext uri="{FF2B5EF4-FFF2-40B4-BE49-F238E27FC236}">
                <a16:creationId xmlns:a16="http://schemas.microsoft.com/office/drawing/2014/main" id="{910A6DCE-4D71-8378-41FA-694070552D3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7" name="Plassholder for dato 6">
            <a:extLst>
              <a:ext uri="{FF2B5EF4-FFF2-40B4-BE49-F238E27FC236}">
                <a16:creationId xmlns:a16="http://schemas.microsoft.com/office/drawing/2014/main" id="{B118CCE6-BF37-DDE8-E9A7-D70609042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264EC-ED58-4D1F-B582-7040A53B7E4B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8" name="Plassholder for bunntekst 7">
            <a:extLst>
              <a:ext uri="{FF2B5EF4-FFF2-40B4-BE49-F238E27FC236}">
                <a16:creationId xmlns:a16="http://schemas.microsoft.com/office/drawing/2014/main" id="{76E03542-A9FF-3F61-AE71-FB6B108003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>
            <a:extLst>
              <a:ext uri="{FF2B5EF4-FFF2-40B4-BE49-F238E27FC236}">
                <a16:creationId xmlns:a16="http://schemas.microsoft.com/office/drawing/2014/main" id="{D1DED339-06AC-3069-3A76-4B734AD683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5BD21-EA6F-4C63-82E2-EC81C088635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0029238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9B53A36A-4C0A-886E-4C2F-91F4CB05DE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dato 2">
            <a:extLst>
              <a:ext uri="{FF2B5EF4-FFF2-40B4-BE49-F238E27FC236}">
                <a16:creationId xmlns:a16="http://schemas.microsoft.com/office/drawing/2014/main" id="{6C877F1C-BE41-4EAA-2B9D-C201B82B7E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264EC-ED58-4D1F-B582-7040A53B7E4B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4" name="Plassholder for bunntekst 3">
            <a:extLst>
              <a:ext uri="{FF2B5EF4-FFF2-40B4-BE49-F238E27FC236}">
                <a16:creationId xmlns:a16="http://schemas.microsoft.com/office/drawing/2014/main" id="{BA545421-2D6C-2795-81BB-FC56787AB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>
            <a:extLst>
              <a:ext uri="{FF2B5EF4-FFF2-40B4-BE49-F238E27FC236}">
                <a16:creationId xmlns:a16="http://schemas.microsoft.com/office/drawing/2014/main" id="{21C3C4D3-F88A-87CA-6DEF-DEDC676DFB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5BD21-EA6F-4C63-82E2-EC81C088635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00078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>
            <a:extLst>
              <a:ext uri="{FF2B5EF4-FFF2-40B4-BE49-F238E27FC236}">
                <a16:creationId xmlns:a16="http://schemas.microsoft.com/office/drawing/2014/main" id="{5CF9F2D1-D105-802C-96C0-BB8512F3C8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264EC-ED58-4D1F-B582-7040A53B7E4B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3" name="Plassholder for bunntekst 2">
            <a:extLst>
              <a:ext uri="{FF2B5EF4-FFF2-40B4-BE49-F238E27FC236}">
                <a16:creationId xmlns:a16="http://schemas.microsoft.com/office/drawing/2014/main" id="{CEEFE58F-C8E8-457D-73A1-D4B62D5EF2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9A8C5B56-02F3-B698-7394-D4F413D4C4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5BD21-EA6F-4C63-82E2-EC81C088635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13793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EF59F2E5-ADA2-7E88-4D33-A9F1FF8CDF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CE4EAA56-75F6-9672-647A-A90B1872CBA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459929C5-E5F2-9A32-DBF3-4EF8C60A75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8929D101-E93D-333F-C5BD-D78726A6B7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264EC-ED58-4D1F-B582-7040A53B7E4B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53ED8ADA-F5DD-A085-5B24-ABA84118C1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CD11460E-FD6F-B8B2-BBA8-3549DB4B23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5BD21-EA6F-4C63-82E2-EC81C088635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497710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6F548CEB-944B-D98E-ADE6-020CEEE4CE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bilde 2">
            <a:extLst>
              <a:ext uri="{FF2B5EF4-FFF2-40B4-BE49-F238E27FC236}">
                <a16:creationId xmlns:a16="http://schemas.microsoft.com/office/drawing/2014/main" id="{173313D4-0B54-7349-AA86-38D0102F606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61CB7CD0-E2B2-7266-13D4-0C4E52F46B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652E9C39-7E04-25F1-6FB7-64850D362B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264EC-ED58-4D1F-B582-7040A53B7E4B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7FB4EAE3-9842-0055-3D1B-83C7DED812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1AE5E428-6CBC-B834-BEE2-F677BCBB5A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5BD21-EA6F-4C63-82E2-EC81C088635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1838989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>
            <a:extLst>
              <a:ext uri="{FF2B5EF4-FFF2-40B4-BE49-F238E27FC236}">
                <a16:creationId xmlns:a16="http://schemas.microsoft.com/office/drawing/2014/main" id="{C9028443-FFA1-7946-935E-2D0F321AF5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B9B07D5E-0202-F903-0146-64305811DA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ABF96F92-702A-6FF0-9AC4-BB841DA6BB7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E264EC-ED58-4D1F-B582-7040A53B7E4B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C0ADF686-F986-CD91-3F51-A9BD52C057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7D34B601-0F8D-8E5F-9CCB-6CD7D3E9F0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25BD21-EA6F-4C63-82E2-EC81C088635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23488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Bilde 4">
            <a:extLst>
              <a:ext uri="{FF2B5EF4-FFF2-40B4-BE49-F238E27FC236}">
                <a16:creationId xmlns:a16="http://schemas.microsoft.com/office/drawing/2014/main" id="{4BB8C92A-5805-73AD-F66B-FD2B942733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0694" y="64830"/>
            <a:ext cx="5773412" cy="4493141"/>
          </a:xfrm>
          <a:prstGeom prst="rect">
            <a:avLst/>
          </a:prstGeom>
        </p:spPr>
      </p:pic>
      <p:sp>
        <p:nvSpPr>
          <p:cNvPr id="2" name="TekstSylinder 1">
            <a:extLst>
              <a:ext uri="{FF2B5EF4-FFF2-40B4-BE49-F238E27FC236}">
                <a16:creationId xmlns:a16="http://schemas.microsoft.com/office/drawing/2014/main" id="{23F08AEF-E0A6-E7B8-B540-58799ECD69FB}"/>
              </a:ext>
            </a:extLst>
          </p:cNvPr>
          <p:cNvSpPr txBox="1"/>
          <p:nvPr/>
        </p:nvSpPr>
        <p:spPr>
          <a:xfrm>
            <a:off x="4578350" y="1352550"/>
            <a:ext cx="1274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Cohort</a:t>
            </a:r>
            <a:r>
              <a:rPr lang="nb-NO" dirty="0"/>
              <a:t> sera</a:t>
            </a:r>
          </a:p>
        </p:txBody>
      </p:sp>
      <p:sp>
        <p:nvSpPr>
          <p:cNvPr id="7" name="TekstSylinder 6">
            <a:extLst>
              <a:ext uri="{FF2B5EF4-FFF2-40B4-BE49-F238E27FC236}">
                <a16:creationId xmlns:a16="http://schemas.microsoft.com/office/drawing/2014/main" id="{9919D7C1-8121-FBFF-5B70-EEE9CC626E18}"/>
              </a:ext>
            </a:extLst>
          </p:cNvPr>
          <p:cNvSpPr txBox="1"/>
          <p:nvPr/>
        </p:nvSpPr>
        <p:spPr>
          <a:xfrm>
            <a:off x="708656" y="4976831"/>
            <a:ext cx="11134094" cy="17377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1100" b="1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Antibody reactivity profile for all cohort participants (n=243).</a:t>
            </a:r>
            <a:r>
              <a:rPr lang="en-US" sz="1100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Unvaccinated and uninfected (n=5, black circles), vaccinated with an unknown infection history (n=14, black squares), infected only (n=81), vaccinated only (n=30) or both infected and vaccinated (n=113). The different combinations of vaccination and infections with order of primary exposures are indicated as follows; primary exposure to Wuhan-like antigens only (purple symbols), to Omicron antigens only (red circles), or primary exposure to Wuhan-like and subsequently Omicron antigens (green). Triangles and circles indicate primary exposure through vaccination and infection respectively. Vax=vaccinated with at least one dose of COVID-19 vaccine, “Wuhan-like” indicates infection with the Wuhan, or the Wuhan-like Alpha or Delta variants. Omicron refers to BA.1, BA.2 or BA.5 infection. </a:t>
            </a:r>
            <a:endParaRPr lang="nb-NO" sz="1400" kern="1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3191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52A0FDAB0C7C884A950652628E07F3E6" ma:contentTypeVersion="20" ma:contentTypeDescription="Opprett et nytt dokument." ma:contentTypeScope="" ma:versionID="21687fabe6b49ba4b82bdd0bb9df9104">
  <xsd:schema xmlns:xsd="http://www.w3.org/2001/XMLSchema" xmlns:xs="http://www.w3.org/2001/XMLSchema" xmlns:p="http://schemas.microsoft.com/office/2006/metadata/properties" xmlns:ns2="9e7c1b5f-6b93-4ee4-9fa2-fda8f1b47cf5" xmlns:ns3="47c382fd-9ec6-40f8-a1b6-1c169c8fba98" xmlns:ns4="12a21d7c-cf9a-41d9-95d1-64d0c3908d52" targetNamespace="http://schemas.microsoft.com/office/2006/metadata/properties" ma:root="true" ma:fieldsID="767553a4dcdaa9cffc4c30e8b88738df" ns2:_="" ns3:_="" ns4:_="">
    <xsd:import namespace="9e7c1b5f-6b93-4ee4-9fa2-fda8f1b47cf5"/>
    <xsd:import namespace="47c382fd-9ec6-40f8-a1b6-1c169c8fba98"/>
    <xsd:import namespace="12a21d7c-cf9a-41d9-95d1-64d0c3908d52"/>
    <xsd:element name="properties">
      <xsd:complexType>
        <xsd:sequence>
          <xsd:element name="documentManagement">
            <xsd:complexType>
              <xsd:all>
                <xsd:element ref="ns2:FHI_TopicTaxHTField" minOccurs="0"/>
                <xsd:element ref="ns3:TaxCatchAll" minOccurs="0"/>
                <xsd:element ref="ns3:TaxKeywordTaxHTField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3:SharedWithUsers" minOccurs="0"/>
                <xsd:element ref="ns3:SharedWithDetails" minOccurs="0"/>
                <xsd:element ref="ns4:MediaServiceDateTaken" minOccurs="0"/>
                <xsd:element ref="ns4:lcf76f155ced4ddcb4097134ff3c332f" minOccurs="0"/>
                <xsd:element ref="ns4:MediaServiceObjectDetectorVersions" minOccurs="0"/>
                <xsd:element ref="ns4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e7c1b5f-6b93-4ee4-9fa2-fda8f1b47cf5" elementFormDefault="qualified">
    <xsd:import namespace="http://schemas.microsoft.com/office/2006/documentManagement/types"/>
    <xsd:import namespace="http://schemas.microsoft.com/office/infopath/2007/PartnerControls"/>
    <xsd:element name="FHI_TopicTaxHTField" ma:index="8" nillable="true" ma:taxonomy="true" ma:internalName="FHI_TopicTaxHTField" ma:taxonomyFieldName="FHI_Topic" ma:displayName="Tema" ma:default="1;#Virussykdommer|fb64bfef-7c21-43bd-a2fe-bc879f296443;#2;#Utbrudd|1d904ff4-3f61-4a6c-a150-748e518b56f3;#3;#Smittevern og vaksiner|595dfd2f-c3fd-4b72-9931-3d6eb156cad9" ma:fieldId="{5eb9fa72-8a58-4312-8bc5-a126a30b4fb3}" ma:taxonomyMulti="true" ma:sspId="e7140caa-8402-4c36-9a5d-f51276ec0a9c" ma:termSetId="10ab213d-8882-42de-b940-43a869fe753a" ma:anchorId="00000000-0000-0000-0000-000000000000" ma:open="fals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7c382fd-9ec6-40f8-a1b6-1c169c8fba98" elementFormDefault="qualified">
    <xsd:import namespace="http://schemas.microsoft.com/office/2006/documentManagement/types"/>
    <xsd:import namespace="http://schemas.microsoft.com/office/infopath/2007/PartnerControls"/>
    <xsd:element name="TaxCatchAll" ma:index="10" nillable="true" ma:displayName="Taxonomy Catch All Column" ma:description="" ma:hidden="true" ma:list="{8d81fa7f-8fd7-4580-9607-57b994b6b2ce}" ma:internalName="TaxCatchAll" ma:showField="CatchAllData" ma:web="47c382fd-9ec6-40f8-a1b6-1c169c8fba98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TaxKeywordTaxHTField" ma:index="11" nillable="true" ma:taxonomy="true" ma:internalName="TaxKeywordTaxHTField" ma:taxonomyFieldName="TaxKeyword" ma:displayName="Organisasjonsnøkkelord" ma:fieldId="{23f27201-bee3-471e-b2e7-b64fd8b7ca38}" ma:taxonomyMulti="true" ma:sspId="e7140caa-8402-4c36-9a5d-f51276ec0a9c" ma:termSetId="00000000-0000-0000-0000-000000000000" ma:anchorId="00000000-0000-0000-0000-000000000000" ma:open="true" ma:isKeyword="true">
      <xsd:complexType>
        <xsd:sequence>
          <xsd:element ref="pc:Terms" minOccurs="0" maxOccurs="1"/>
        </xsd:sequence>
      </xsd:complexType>
    </xsd:element>
    <xsd:element name="SharedWithUsers" ma:index="21" nillable="true" ma:displayName="Delt med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Delingsdetaljer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2a21d7c-cf9a-41d9-95d1-64d0c3908d5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3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4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7" nillable="true" ma:displayName="Tags" ma:internalName="MediaServiceAutoTags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23" nillable="true" ma:displayName="MediaServiceDateTaken" ma:hidden="true" ma:internalName="MediaServiceDateTaken" ma:readOnly="true">
      <xsd:simpleType>
        <xsd:restriction base="dms:Text"/>
      </xsd:simpleType>
    </xsd:element>
    <xsd:element name="lcf76f155ced4ddcb4097134ff3c332f" ma:index="25" nillable="true" ma:taxonomy="true" ma:internalName="lcf76f155ced4ddcb4097134ff3c332f" ma:taxonomyFieldName="MediaServiceImageTags" ma:displayName="Bildemerkelapper" ma:readOnly="false" ma:fieldId="{5cf76f15-5ced-4ddc-b409-7134ff3c332f}" ma:taxonomyMulti="true" ma:sspId="e7140caa-8402-4c36-9a5d-f51276ec0a9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6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7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nholdstype"/>
        <xsd:element ref="dc:title" minOccurs="0" maxOccurs="1" ma:index="4" ma:displayName="Tit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12a21d7c-cf9a-41d9-95d1-64d0c3908d52">
      <Terms xmlns="http://schemas.microsoft.com/office/infopath/2007/PartnerControls"/>
    </lcf76f155ced4ddcb4097134ff3c332f>
    <TaxKeywordTaxHTField xmlns="47c382fd-9ec6-40f8-a1b6-1c169c8fba98">
      <Terms xmlns="http://schemas.microsoft.com/office/infopath/2007/PartnerControls"/>
    </TaxKeywordTaxHTField>
    <FHI_TopicTaxHTField xmlns="9e7c1b5f-6b93-4ee4-9fa2-fda8f1b47cf5">
      <Terms xmlns="http://schemas.microsoft.com/office/infopath/2007/PartnerControls">
        <TermInfo xmlns="http://schemas.microsoft.com/office/infopath/2007/PartnerControls">
          <TermName xmlns="http://schemas.microsoft.com/office/infopath/2007/PartnerControls">Virussykdommer</TermName>
          <TermId xmlns="http://schemas.microsoft.com/office/infopath/2007/PartnerControls">fb64bfef-7c21-43bd-a2fe-bc879f296443</TermId>
        </TermInfo>
        <TermInfo xmlns="http://schemas.microsoft.com/office/infopath/2007/PartnerControls">
          <TermName xmlns="http://schemas.microsoft.com/office/infopath/2007/PartnerControls">Utbrudd</TermName>
          <TermId xmlns="http://schemas.microsoft.com/office/infopath/2007/PartnerControls">1d904ff4-3f61-4a6c-a150-748e518b56f3</TermId>
        </TermInfo>
        <TermInfo xmlns="http://schemas.microsoft.com/office/infopath/2007/PartnerControls">
          <TermName xmlns="http://schemas.microsoft.com/office/infopath/2007/PartnerControls">Smittevern og vaksiner</TermName>
          <TermId xmlns="http://schemas.microsoft.com/office/infopath/2007/PartnerControls">595dfd2f-c3fd-4b72-9931-3d6eb156cad9</TermId>
        </TermInfo>
      </Terms>
    </FHI_TopicTaxHTField>
    <TaxCatchAll xmlns="47c382fd-9ec6-40f8-a1b6-1c169c8fba98">
      <Value>3</Value>
      <Value>2</Value>
      <Value>1</Value>
    </TaxCatchAll>
  </documentManagement>
</p:properties>
</file>

<file path=customXml/itemProps1.xml><?xml version="1.0" encoding="utf-8"?>
<ds:datastoreItem xmlns:ds="http://schemas.openxmlformats.org/officeDocument/2006/customXml" ds:itemID="{477D3685-9000-4DAD-A1EF-BFB31911628E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97539C17-5862-4B69-93C2-92CA5E5B9FD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e7c1b5f-6b93-4ee4-9fa2-fda8f1b47cf5"/>
    <ds:schemaRef ds:uri="47c382fd-9ec6-40f8-a1b6-1c169c8fba98"/>
    <ds:schemaRef ds:uri="12a21d7c-cf9a-41d9-95d1-64d0c3908d5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BEEF9D4A-1286-4945-99DD-14BCB6061CC2}">
  <ds:schemaRefs>
    <ds:schemaRef ds:uri="http://schemas.microsoft.com/office/2006/metadata/properties"/>
    <ds:schemaRef ds:uri="http://schemas.microsoft.com/office/infopath/2007/PartnerControls"/>
    <ds:schemaRef ds:uri="12a21d7c-cf9a-41d9-95d1-64d0c3908d52"/>
    <ds:schemaRef ds:uri="47c382fd-9ec6-40f8-a1b6-1c169c8fba98"/>
    <ds:schemaRef ds:uri="9e7c1b5f-6b93-4ee4-9fa2-fda8f1b47cf5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2</Words>
  <Application>Microsoft Office PowerPoint</Application>
  <PresentationFormat>Widescreen</PresentationFormat>
  <Paragraphs>3</Paragraphs>
  <Slides>1</Slides>
  <Notes>1</Notes>
  <HiddenSlides>0</HiddenSlides>
  <MMClips>0</MMClips>
  <ScaleCrop>false</ScaleCrop>
  <HeadingPairs>
    <vt:vector size="6" baseType="variant">
      <vt:variant>
        <vt:lpstr>Brukte skrifter</vt:lpstr>
      </vt:variant>
      <vt:variant>
        <vt:i4>3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esentasj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Gro Tunheim</dc:creator>
  <cp:lastModifiedBy>Gro Tunheim</cp:lastModifiedBy>
  <cp:revision>1</cp:revision>
  <dcterms:created xsi:type="dcterms:W3CDTF">2023-09-28T09:20:00Z</dcterms:created>
  <dcterms:modified xsi:type="dcterms:W3CDTF">2024-08-08T12:28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2A0FDAB0C7C884A950652628E07F3E6</vt:lpwstr>
  </property>
  <property fmtid="{D5CDD505-2E9C-101B-9397-08002B2CF9AE}" pid="3" name="FHI_Topic">
    <vt:lpwstr>1;#Virussykdommer|fb64bfef-7c21-43bd-a2fe-bc879f296443;#2;#Utbrudd|1d904ff4-3f61-4a6c-a150-748e518b56f3;#3;#Smittevern og vaksiner|595dfd2f-c3fd-4b72-9931-3d6eb156cad9</vt:lpwstr>
  </property>
  <property fmtid="{D5CDD505-2E9C-101B-9397-08002B2CF9AE}" pid="4" name="TaxKeyword">
    <vt:lpwstr/>
  </property>
  <property fmtid="{D5CDD505-2E9C-101B-9397-08002B2CF9AE}" pid="5" name="MediaServiceImageTags">
    <vt:lpwstr/>
  </property>
</Properties>
</file>